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D87D3D7-033D-40CD-8E99-E68847E92CE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CF42A30-0FB2-4311-B7E0-E04A87C41E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A3A7625-78AC-4684-9827-A36824CE45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4B0FE43-0F58-4013-8684-035783B250D6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458F2F6-BC87-421C-8175-EEB04C3E8F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A2CB52C-BCF2-4D1D-B4B0-CCD0E31FDC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A3508D2-09C3-417D-AFA7-51A4717B39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7FB01D9-6203-426D-B2C8-F0ABF0D23E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BE79D1A-F12C-41F0-BD6B-17ECDBEB1C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2017A14-30D4-4E5C-911D-D2715286F6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9C6B03B-6C31-4E4F-A435-C48CE77DD1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758C1C1-957E-4C2F-B297-83F493DFF5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9/15/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A86FF746-1130-4A1A-9AD7-1023790BC112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860640" y="528480"/>
            <a:ext cx="2273400" cy="22734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1587600" y="528480"/>
            <a:ext cx="2273040" cy="22734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6134040" y="528480"/>
            <a:ext cx="2273400" cy="22734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1587600" y="2954160"/>
            <a:ext cx="2273040" cy="22734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3860640" y="2954160"/>
            <a:ext cx="2273400" cy="22734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tretch/>
        </p:blipFill>
        <p:spPr>
          <a:xfrm>
            <a:off x="6134040" y="2954160"/>
            <a:ext cx="2273400" cy="22734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2250720" y="38160"/>
            <a:ext cx="695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x 5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649760" y="38160"/>
            <a:ext cx="695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x 8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837480" y="38160"/>
            <a:ext cx="81000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x 10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87080" y="1481040"/>
            <a:ext cx="88020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88880" y="3906720"/>
            <a:ext cx="788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DD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58760" y="5591160"/>
            <a:ext cx="8712360" cy="91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dditional fi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Historogical change of sciatic nerve after the fourth administration of CDDP.  No significant differences were observed between the control and 17:00-treated groups.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